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74" d="100"/>
          <a:sy n="74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85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113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229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902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33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369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50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73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384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71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00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228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85F9060-D732-C44E-A1AA-6234B26243F1}"/>
              </a:ext>
            </a:extLst>
          </p:cNvPr>
          <p:cNvSpPr txBox="1"/>
          <p:nvPr/>
        </p:nvSpPr>
        <p:spPr>
          <a:xfrm>
            <a:off x="278362" y="592153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a) Task 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8C6AC34-FF35-BD4E-BB0D-456F1DC4936D}"/>
              </a:ext>
            </a:extLst>
          </p:cNvPr>
          <p:cNvSpPr txBox="1"/>
          <p:nvPr/>
        </p:nvSpPr>
        <p:spPr>
          <a:xfrm>
            <a:off x="228668" y="4452898"/>
            <a:ext cx="89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b) Task 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2587DD2-9A17-C24F-9247-94BEFD5B70A3}"/>
              </a:ext>
            </a:extLst>
          </p:cNvPr>
          <p:cNvSpPr txBox="1"/>
          <p:nvPr/>
        </p:nvSpPr>
        <p:spPr>
          <a:xfrm>
            <a:off x="257244" y="8340785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c) Task 3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A118DA1-CBA0-D442-8817-8DD319E26C45}"/>
              </a:ext>
            </a:extLst>
          </p:cNvPr>
          <p:cNvSpPr txBox="1"/>
          <p:nvPr/>
        </p:nvSpPr>
        <p:spPr>
          <a:xfrm>
            <a:off x="146880" y="68933"/>
            <a:ext cx="55509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>
                <a:latin typeface="Helvetica" pitchFamily="2" charset="0"/>
              </a:rPr>
              <a:t>Supplementary Figure </a:t>
            </a:r>
            <a:r>
              <a:rPr kumimoji="1" lang="en-US" altLang="ja-JP" sz="1400" dirty="0">
                <a:latin typeface="Helvetica" pitchFamily="2" charset="0"/>
              </a:rPr>
              <a:t>3</a:t>
            </a:r>
            <a:r>
              <a:rPr kumimoji="1" lang="en-US" altLang="ja-JP" sz="1400">
                <a:latin typeface="Helvetica" pitchFamily="2" charset="0"/>
              </a:rPr>
              <a:t>.  </a:t>
            </a:r>
            <a:r>
              <a:rPr kumimoji="1" lang="en-US" altLang="ja-JP" sz="1400" dirty="0">
                <a:latin typeface="Helvetica" pitchFamily="2" charset="0"/>
              </a:rPr>
              <a:t>ALL scores at the time of participants’ 1st training session divided by the ESSQ qualification status</a:t>
            </a:r>
            <a:endParaRPr kumimoji="1" lang="ja-JP" altLang="en-US" sz="1400">
              <a:latin typeface="Helvetica" pitchFamily="2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740059D2-E7E5-C64E-A564-6800D699E1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0206" y="631566"/>
            <a:ext cx="5009858" cy="3729142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841FC2D-7A83-AF46-ADC3-B5797F35BCEA}"/>
              </a:ext>
            </a:extLst>
          </p:cNvPr>
          <p:cNvSpPr txBox="1"/>
          <p:nvPr/>
        </p:nvSpPr>
        <p:spPr>
          <a:xfrm>
            <a:off x="4752607" y="3270494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60374013-E0A0-A749-8A18-41219DB3EF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0206" y="4540121"/>
            <a:ext cx="5037057" cy="3749388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29EB731-34D0-3746-978D-36053242FA63}"/>
              </a:ext>
            </a:extLst>
          </p:cNvPr>
          <p:cNvSpPr txBox="1"/>
          <p:nvPr/>
        </p:nvSpPr>
        <p:spPr>
          <a:xfrm>
            <a:off x="4832647" y="7168466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B4D0EE7F-E9B1-E242-8A27-1559A72A21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8752" y="8416654"/>
            <a:ext cx="5009858" cy="3729143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27B508A-98CB-CD4B-840D-A3306DF33E08}"/>
              </a:ext>
            </a:extLst>
          </p:cNvPr>
          <p:cNvSpPr txBox="1"/>
          <p:nvPr/>
        </p:nvSpPr>
        <p:spPr>
          <a:xfrm>
            <a:off x="4815554" y="11113396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2910450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9</TotalTime>
  <Words>54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20</cp:revision>
  <dcterms:created xsi:type="dcterms:W3CDTF">2019-11-29T23:13:51Z</dcterms:created>
  <dcterms:modified xsi:type="dcterms:W3CDTF">2020-05-18T05:17:39Z</dcterms:modified>
</cp:coreProperties>
</file>